
<file path=[Content_Types].xml><?xml version="1.0" encoding="utf-8"?>
<Types xmlns="http://schemas.openxmlformats.org/package/2006/content-types">
  <Default Extension="avi" ContentType="video/x-msvideo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5" r:id="rId2"/>
    <p:sldId id="257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EB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296" autoAdjust="0"/>
    <p:restoredTop sz="90262" autoAdjust="0"/>
  </p:normalViewPr>
  <p:slideViewPr>
    <p:cSldViewPr snapToGrid="0" snapToObjects="1">
      <p:cViewPr varScale="1">
        <p:scale>
          <a:sx n="93" d="100"/>
          <a:sy n="93" d="100"/>
        </p:scale>
        <p:origin x="2440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1B5AF2-5223-7646-960D-94DB5F208839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C1810-814B-F04B-A5BF-3BBF88B3F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254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25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47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6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13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2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20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4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61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92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6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84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88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3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microsoft.com/office/2007/relationships/hdphoto" Target="../media/hdphoto1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0" Type="http://schemas.microsoft.com/office/2007/relationships/hdphoto" Target="../media/hdphoto3.wdp"/><Relationship Id="rId4" Type="http://schemas.openxmlformats.org/officeDocument/2006/relationships/image" Target="../media/image1.tif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B77FDDC-822B-A445-BA68-3439E1F7BDF7}"/>
              </a:ext>
            </a:extLst>
          </p:cNvPr>
          <p:cNvSpPr/>
          <p:nvPr/>
        </p:nvSpPr>
        <p:spPr>
          <a:xfrm>
            <a:off x="270166" y="635851"/>
            <a:ext cx="6324601" cy="69249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lony spreading of </a:t>
            </a:r>
            <a:r>
              <a:rPr lang="en-US" altLang="ja-JP" sz="12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lavobacterium johnsoniae</a:t>
            </a: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has a cell surface adhesin-independent phase: Machinery of biofilm gliding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*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sami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ri Hat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oshio Kond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a Narit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eiji Nag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ko Nai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oji Nakayam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hikara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*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 and Oral Infection, Nagasaki University Graduate School of Biomedical Sciences, Nagasaki, Nagasaki 852-8588, Japan. 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Biomedical Research Institute, Advanced Industrial Science and Technology (AIST), Tsukuba, Ibaraki 305-8566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Pediatric Dentistry, Graduate School of Biomedical Sciences, Nagasaki University, 1-7-1 Sakamoto, Nagasaki 852-8588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Functional Bioscience, Infection Biology, Fukuoka Dental College, Matsudo, Tamura, Sawara, Fukuoka 814-0913, Japan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, Health Sciences University of Hokkaido, 1757 Kanazawa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etsu-ch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shikari-gun, Hokkaido 061-0293, Japan</a:t>
            </a:r>
          </a:p>
          <a:p>
            <a:pPr>
              <a:lnSpc>
                <a:spcPct val="150000"/>
              </a:lnSpc>
            </a:pPr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spondanc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o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,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. D. [E-mail: satou@nagasaki-u.ac.jp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kar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ato, Ph. D. [E-mail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-sato@aist.go.jp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</a:t>
            </a:r>
            <a:r>
              <a:rPr lang="en-US" altLang="ja-JP" sz="1200" b="1" kern="10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s S2e3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2480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258E5206-CB96-EF4E-9DA5-8FC5BE97FFA9}"/>
              </a:ext>
            </a:extLst>
          </p:cNvPr>
          <p:cNvSpPr/>
          <p:nvPr/>
        </p:nvSpPr>
        <p:spPr>
          <a:xfrm>
            <a:off x="1" y="-18901"/>
            <a:ext cx="9653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Calibri" panose="020F0502020204030204" pitchFamily="34" charset="0"/>
                <a:ea typeface="Arial Unicode MS" charset="0"/>
                <a:cs typeface="Calibri" panose="020F0502020204030204" pitchFamily="34" charset="0"/>
              </a:rPr>
              <a:t>Fig</a:t>
            </a:r>
            <a:r>
              <a:rPr lang="en-US" altLang="ja-JP">
                <a:latin typeface="Calibri" panose="020F0502020204030204" pitchFamily="34" charset="0"/>
                <a:ea typeface="Arial Unicode MS" charset="0"/>
                <a:cs typeface="Calibri" panose="020F0502020204030204" pitchFamily="34" charset="0"/>
              </a:rPr>
              <a:t>.S2e3</a:t>
            </a:r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6" name="図 5" descr="BF223_8bit.tif">
            <a:extLst>
              <a:ext uri="{FF2B5EF4-FFF2-40B4-BE49-F238E27FC236}">
                <a16:creationId xmlns:a16="http://schemas.microsoft.com/office/drawing/2014/main" id="{81280469-2680-0E42-A658-F0054308C92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3512" y="1066796"/>
            <a:ext cx="3200400" cy="3200400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5FA1A163-4944-F546-8953-1B1224307508}"/>
              </a:ext>
            </a:extLst>
          </p:cNvPr>
          <p:cNvSpPr/>
          <p:nvPr/>
        </p:nvSpPr>
        <p:spPr>
          <a:xfrm>
            <a:off x="3343912" y="456568"/>
            <a:ext cx="347252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+mj-lt"/>
                <a:ea typeface="Arial Unicode MS" panose="020B0604020202020204" pitchFamily="34" charset="-128"/>
                <a:cs typeface="Times New Roman" panose="02020603050405020304" pitchFamily="18" charset="0"/>
              </a:rPr>
              <a:t>Confocal 3D map</a:t>
            </a:r>
            <a:r>
              <a:rPr lang="ja-JP" altLang="ja-JP" sz="1600">
                <a:latin typeface="+mj-lt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+mj-lt"/>
                <a:ea typeface="Arial Unicode MS" panose="020B0604020202020204" pitchFamily="34" charset="-128"/>
                <a:cs typeface="Times New Roman" panose="02020603050405020304" pitchFamily="18" charset="0"/>
              </a:rPr>
              <a:t>of GFP-labeled cells</a:t>
            </a:r>
            <a:endParaRPr lang="ja-JP" altLang="en-US" sz="16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B280993-CD51-4749-92BF-4FAB47A41B6A}"/>
              </a:ext>
            </a:extLst>
          </p:cNvPr>
          <p:cNvSpPr txBox="1"/>
          <p:nvPr/>
        </p:nvSpPr>
        <p:spPr>
          <a:xfrm>
            <a:off x="231083" y="705947"/>
            <a:ext cx="17491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+mj-lt"/>
                <a:cs typeface="Times New Roman" panose="02020603050405020304" pitchFamily="18" charset="0"/>
              </a:rPr>
              <a:t>Phase contrast OM</a:t>
            </a:r>
            <a:endParaRPr kumimoji="1" lang="ja-JP" altLang="en-US" sz="16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27D7148-17A1-F04D-8F99-1D994FE4D5EB}"/>
              </a:ext>
            </a:extLst>
          </p:cNvPr>
          <p:cNvSpPr txBox="1"/>
          <p:nvPr/>
        </p:nvSpPr>
        <p:spPr>
          <a:xfrm>
            <a:off x="907747" y="7707867"/>
            <a:ext cx="4822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Top</a:t>
            </a:r>
            <a:endParaRPr kumimoji="1" lang="ja-JP" altLang="en-US" sz="160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4BE711C-2F40-C741-A823-1DF4A69993C7}"/>
              </a:ext>
            </a:extLst>
          </p:cNvPr>
          <p:cNvSpPr txBox="1"/>
          <p:nvPr/>
        </p:nvSpPr>
        <p:spPr>
          <a:xfrm>
            <a:off x="3028037" y="7707867"/>
            <a:ext cx="7697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Middle</a:t>
            </a:r>
            <a:endParaRPr kumimoji="1" lang="ja-JP" altLang="en-US" sz="160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378AF62-6B6F-F24E-9122-D282D8BAD4F5}"/>
              </a:ext>
            </a:extLst>
          </p:cNvPr>
          <p:cNvSpPr txBox="1"/>
          <p:nvPr/>
        </p:nvSpPr>
        <p:spPr>
          <a:xfrm>
            <a:off x="5271277" y="7707867"/>
            <a:ext cx="8113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Bottom</a:t>
            </a:r>
            <a:endParaRPr kumimoji="1" lang="ja-JP" altLang="en-US" sz="1600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839BC85C-BC96-F147-B2A9-CB4B3E96600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84289" y="5548682"/>
            <a:ext cx="2140398" cy="2140398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0512A314-4ADF-CA40-8CC2-1B06A5D7071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42719" y="5548685"/>
            <a:ext cx="2140396" cy="2140396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21380807-A37E-C04C-B771-13339EC1109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33314" y="5548682"/>
            <a:ext cx="2140399" cy="2140399"/>
          </a:xfrm>
          <a:prstGeom prst="rect">
            <a:avLst/>
          </a:prstGeom>
        </p:spPr>
      </p:pic>
      <p:pic>
        <p:nvPicPr>
          <p:cNvPr id="22" name="オンライン メディア 21" descr="Stack_3d_24to73_Green">
            <a:hlinkClick r:id="" action="ppaction://media"/>
            <a:extLst>
              <a:ext uri="{FF2B5EF4-FFF2-40B4-BE49-F238E27FC236}">
                <a16:creationId xmlns:a16="http://schemas.microsoft.com/office/drawing/2014/main" id="{AF99DDA3-E291-3D47-AA38-5CB7C69CEE4A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1"/>
          <a:stretch>
            <a:fillRect/>
          </a:stretch>
        </p:blipFill>
        <p:spPr>
          <a:xfrm>
            <a:off x="3479972" y="1066795"/>
            <a:ext cx="3200401" cy="3200401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15B26FB-8A7C-8346-8D73-9E56E46D6404}"/>
              </a:ext>
            </a:extLst>
          </p:cNvPr>
          <p:cNvSpPr txBox="1"/>
          <p:nvPr/>
        </p:nvSpPr>
        <p:spPr>
          <a:xfrm>
            <a:off x="3609161" y="731805"/>
            <a:ext cx="29420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600" dirty="0"/>
              <a:t>Movie representation of 3D stack</a:t>
            </a:r>
            <a:endParaRPr kumimoji="1" lang="ja-JP" altLang="en-US" sz="1600"/>
          </a:p>
        </p:txBody>
      </p:sp>
    </p:spTree>
    <p:extLst>
      <p:ext uri="{BB962C8B-B14F-4D97-AF65-F5344CB8AC3E}">
        <p14:creationId xmlns:p14="http://schemas.microsoft.com/office/powerpoint/2010/main" val="285938202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857" fill="hold"/>
                                        <p:tgtEl>
                                          <p:spTgt spid="2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54</TotalTime>
  <Words>222</Words>
  <Application>Microsoft Macintosh PowerPoint</Application>
  <PresentationFormat>画面に合わせる (4:3)</PresentationFormat>
  <Paragraphs>23</Paragraphs>
  <Slides>2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明朝</vt:lpstr>
      <vt:lpstr>Arial</vt:lpstr>
      <vt:lpstr>Calibri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啓子</dc:creator>
  <cp:lastModifiedBy>佐藤　啓子</cp:lastModifiedBy>
  <cp:revision>339</cp:revision>
  <cp:lastPrinted>2020-08-18T02:49:06Z</cp:lastPrinted>
  <dcterms:created xsi:type="dcterms:W3CDTF">2017-02-28T00:50:21Z</dcterms:created>
  <dcterms:modified xsi:type="dcterms:W3CDTF">2020-11-20T14:38:45Z</dcterms:modified>
</cp:coreProperties>
</file>